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08813" cy="120380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0B15B0-35E0-4982-939B-3F2B2898DCE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5DF87A-810A-4DC7-B5DE-A194EA0122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9D9394-C7C2-41CB-8EC7-C608C81E429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AC4A3A-7CB0-48FC-9E15-2A450841483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6BF547-F171-4E48-96D7-C80B712CA1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6E12FE-9A31-4B51-920F-EF6FFE4592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DD0A6F-1E5A-4176-871D-D90671D6EE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DC274B-7068-4DE5-BD3E-6D4DA417CAD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699821-55B7-452A-93C8-473F33FCAEA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59E1D0-352B-4255-B557-1B40722FDA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6595EB-946B-475E-A6F0-E624E04DB1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98F543-C54F-4D4A-BE23-AF38108D44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5A5175B-CBA1-4BF3-8442-8D95A861FB7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535320" y="187920"/>
            <a:ext cx="4063320" cy="6533640"/>
            <a:chOff x="535320" y="187920"/>
            <a:chExt cx="4063320" cy="6533640"/>
          </a:xfrm>
        </p:grpSpPr>
        <p:grpSp>
          <p:nvGrpSpPr>
            <p:cNvPr id="42" name=""/>
            <p:cNvGrpSpPr/>
            <p:nvPr/>
          </p:nvGrpSpPr>
          <p:grpSpPr>
            <a:xfrm>
              <a:off x="535320" y="208800"/>
              <a:ext cx="3539160" cy="5829120"/>
              <a:chOff x="535320" y="208800"/>
              <a:chExt cx="3539160" cy="5829120"/>
            </a:xfrm>
          </p:grpSpPr>
          <p:sp>
            <p:nvSpPr>
              <p:cNvPr id="43" name=""/>
              <p:cNvSpPr/>
              <p:nvPr/>
            </p:nvSpPr>
            <p:spPr>
              <a:xfrm>
                <a:off x="535320" y="3086280"/>
                <a:ext cx="181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" name=""/>
              <p:cNvSpPr/>
              <p:nvPr/>
            </p:nvSpPr>
            <p:spPr>
              <a:xfrm flipV="1">
                <a:off x="717120" y="668160"/>
                <a:ext cx="0" cy="2417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717120" y="668520"/>
                <a:ext cx="5022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 flipV="1">
                <a:off x="1219320" y="476280"/>
                <a:ext cx="0" cy="192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1219320" y="476280"/>
                <a:ext cx="96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 flipV="1">
                <a:off x="1315440" y="251280"/>
                <a:ext cx="0" cy="224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1315440" y="251280"/>
                <a:ext cx="964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 flipV="1">
                <a:off x="1412280" y="208800"/>
                <a:ext cx="0" cy="42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" bIns="-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1412280" y="209160"/>
                <a:ext cx="4273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1412280" y="251280"/>
                <a:ext cx="0" cy="53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1412280" y="305280"/>
                <a:ext cx="5666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1315440" y="476280"/>
                <a:ext cx="0" cy="213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1315440" y="690120"/>
                <a:ext cx="640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 flipV="1">
                <a:off x="1379880" y="551160"/>
                <a:ext cx="0" cy="1389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1379880" y="551160"/>
                <a:ext cx="1713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 flipV="1">
                <a:off x="1551240" y="454320"/>
                <a:ext cx="0" cy="96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1551240" y="454680"/>
                <a:ext cx="96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 flipV="1">
                <a:off x="1647360" y="401400"/>
                <a:ext cx="0" cy="53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480" bIns="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1647360" y="401400"/>
                <a:ext cx="42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1647360" y="454680"/>
                <a:ext cx="0" cy="42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1647360" y="49752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1551240" y="551160"/>
                <a:ext cx="0" cy="96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1551240" y="647280"/>
                <a:ext cx="42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 flipV="1">
                <a:off x="1593720" y="604440"/>
                <a:ext cx="0" cy="42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" bIns="-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1593720" y="604800"/>
                <a:ext cx="1173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1593720" y="647280"/>
                <a:ext cx="0" cy="53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1593720" y="700920"/>
                <a:ext cx="1389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1379880" y="690120"/>
                <a:ext cx="0" cy="1497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1379880" y="839880"/>
                <a:ext cx="352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 flipV="1">
                <a:off x="1732680" y="796680"/>
                <a:ext cx="0" cy="42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1732680" y="797040"/>
                <a:ext cx="1069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1732680" y="839880"/>
                <a:ext cx="0" cy="53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480" bIns="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1732680" y="893520"/>
                <a:ext cx="74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1219320" y="668520"/>
                <a:ext cx="0" cy="3207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1219320" y="989640"/>
                <a:ext cx="4917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 flipV="1">
                <a:off x="717120" y="1299600"/>
                <a:ext cx="0" cy="17863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717120" y="1299600"/>
                <a:ext cx="1657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 flipV="1">
                <a:off x="2374560" y="1085760"/>
                <a:ext cx="0" cy="213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2374560" y="1085760"/>
                <a:ext cx="5130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2374560" y="1299600"/>
                <a:ext cx="0" cy="245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2374560" y="1545840"/>
                <a:ext cx="7164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 flipV="1">
                <a:off x="3091320" y="1181880"/>
                <a:ext cx="0" cy="3636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3091320" y="1181880"/>
                <a:ext cx="5022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3091320" y="1545840"/>
                <a:ext cx="0" cy="3099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3091320" y="1855800"/>
                <a:ext cx="1386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 flipV="1">
                <a:off x="3229920" y="1406520"/>
                <a:ext cx="0" cy="448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3229920" y="1406880"/>
                <a:ext cx="320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 flipV="1">
                <a:off x="3262320" y="1331640"/>
                <a:ext cx="0" cy="745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720" bIns="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3262320" y="1332000"/>
                <a:ext cx="4489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 flipV="1">
                <a:off x="3711240" y="1278000"/>
                <a:ext cx="0" cy="53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3711240" y="1278360"/>
                <a:ext cx="21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3711240" y="1332000"/>
                <a:ext cx="0" cy="53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480" bIns="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3711240" y="1385280"/>
                <a:ext cx="428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3262320" y="1406880"/>
                <a:ext cx="0" cy="745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720" bIns="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3262320" y="1481760"/>
                <a:ext cx="4597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3229920" y="1855800"/>
                <a:ext cx="0" cy="438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3229920" y="2294640"/>
                <a:ext cx="21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 flipV="1">
                <a:off x="3251160" y="1877400"/>
                <a:ext cx="0" cy="416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3251160" y="1877400"/>
                <a:ext cx="245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 flipV="1">
                <a:off x="3497400" y="1695240"/>
                <a:ext cx="0" cy="181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3497400" y="1695600"/>
                <a:ext cx="31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 flipV="1">
                <a:off x="3529440" y="1620360"/>
                <a:ext cx="0" cy="745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720" bIns="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3529440" y="1620720"/>
                <a:ext cx="21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 flipV="1">
                <a:off x="3550680" y="1577520"/>
                <a:ext cx="0" cy="42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3550680" y="157788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3550680" y="1620720"/>
                <a:ext cx="0" cy="53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480" bIns="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3550680" y="1674000"/>
                <a:ext cx="1497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3529440" y="1695600"/>
                <a:ext cx="0" cy="745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720" bIns="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3529440" y="1770120"/>
                <a:ext cx="428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3497400" y="1877400"/>
                <a:ext cx="0" cy="203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3497400" y="2080800"/>
                <a:ext cx="2350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 flipV="1">
                <a:off x="3732480" y="1984320"/>
                <a:ext cx="0" cy="96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3732480" y="1984680"/>
                <a:ext cx="31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 flipV="1">
                <a:off x="3764520" y="1920240"/>
                <a:ext cx="0" cy="640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280" bIns="17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3764520" y="1920240"/>
                <a:ext cx="10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 flipV="1">
                <a:off x="3775320" y="1866960"/>
                <a:ext cx="0" cy="53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480" bIns="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3775320" y="186696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3775320" y="1920240"/>
                <a:ext cx="0" cy="42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3775320" y="196308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>
                <a:off x="3764520" y="1984680"/>
                <a:ext cx="0" cy="745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720" bIns="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3764520" y="2059200"/>
                <a:ext cx="640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3732480" y="2080800"/>
                <a:ext cx="0" cy="745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720" bIns="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3732480" y="215568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3251160" y="2294640"/>
                <a:ext cx="0" cy="395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3251160" y="2690280"/>
                <a:ext cx="964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 flipV="1">
                <a:off x="3348000" y="2262600"/>
                <a:ext cx="0" cy="4276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3348000" y="2262600"/>
                <a:ext cx="2563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3348000" y="2690280"/>
                <a:ext cx="0" cy="395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3348000" y="3086280"/>
                <a:ext cx="31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 flipV="1">
                <a:off x="3379680" y="2658240"/>
                <a:ext cx="0" cy="4276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3379680" y="2658240"/>
                <a:ext cx="85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 flipV="1">
                <a:off x="3465360" y="2476080"/>
                <a:ext cx="0" cy="181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3465360" y="2476440"/>
                <a:ext cx="532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 flipV="1">
                <a:off x="3518640" y="2401200"/>
                <a:ext cx="0" cy="745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720" bIns="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3518640" y="2401560"/>
                <a:ext cx="96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 flipV="1">
                <a:off x="3615120" y="2358360"/>
                <a:ext cx="0" cy="42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3615120" y="235872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3615120" y="2401560"/>
                <a:ext cx="0" cy="53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480" bIns="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3615120" y="245520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3518640" y="2476440"/>
                <a:ext cx="0" cy="745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720" bIns="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3518640" y="2551320"/>
                <a:ext cx="1065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3465360" y="2658240"/>
                <a:ext cx="0" cy="181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3465360" y="2840040"/>
                <a:ext cx="532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 flipV="1">
                <a:off x="3518640" y="2700720"/>
                <a:ext cx="0" cy="1389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3518640" y="2700720"/>
                <a:ext cx="640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 flipV="1">
                <a:off x="3583080" y="2647440"/>
                <a:ext cx="0" cy="53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480" bIns="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3583080" y="2647440"/>
                <a:ext cx="1598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3583080" y="2700720"/>
                <a:ext cx="0" cy="42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3583080" y="2743560"/>
                <a:ext cx="127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>
                <a:off x="3518640" y="2840040"/>
                <a:ext cx="0" cy="1497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3518640" y="2989800"/>
                <a:ext cx="2030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 flipV="1">
                <a:off x="3722040" y="2893320"/>
                <a:ext cx="0" cy="96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>
                <a:off x="3722040" y="2893680"/>
                <a:ext cx="42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 flipV="1">
                <a:off x="3764520" y="2839680"/>
                <a:ext cx="0" cy="53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>
                <a:off x="3764520" y="284004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3764520" y="2893680"/>
                <a:ext cx="0" cy="42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" bIns="-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3764520" y="293616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>
                <a:off x="3722040" y="2989800"/>
                <a:ext cx="0" cy="96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>
                <a:off x="3722040" y="3086280"/>
                <a:ext cx="532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 flipV="1">
                <a:off x="3775320" y="3043080"/>
                <a:ext cx="0" cy="42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3775320" y="3043440"/>
                <a:ext cx="2991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3775320" y="3086280"/>
                <a:ext cx="0" cy="53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480" bIns="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3775320" y="3139560"/>
                <a:ext cx="2030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3379680" y="3086280"/>
                <a:ext cx="0" cy="4276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3379680" y="3513960"/>
                <a:ext cx="10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 flipV="1">
                <a:off x="3390120" y="3235680"/>
                <a:ext cx="0" cy="277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>
                <a:off x="3390120" y="3235680"/>
                <a:ext cx="21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>
                <a:off x="3390120" y="3513960"/>
                <a:ext cx="0" cy="277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>
                <a:off x="3390120" y="3791880"/>
                <a:ext cx="10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"/>
              <p:cNvSpPr/>
              <p:nvPr/>
            </p:nvSpPr>
            <p:spPr>
              <a:xfrm flipV="1">
                <a:off x="3401280" y="3374640"/>
                <a:ext cx="0" cy="416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>
                <a:off x="3401280" y="3374640"/>
                <a:ext cx="428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 flipV="1">
                <a:off x="3444120" y="3331440"/>
                <a:ext cx="0" cy="42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"/>
              <p:cNvSpPr/>
              <p:nvPr/>
            </p:nvSpPr>
            <p:spPr>
              <a:xfrm>
                <a:off x="3444120" y="333180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"/>
              <p:cNvSpPr/>
              <p:nvPr/>
            </p:nvSpPr>
            <p:spPr>
              <a:xfrm>
                <a:off x="3444120" y="3374640"/>
                <a:ext cx="0" cy="53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>
                <a:off x="3444120" y="342864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>
                <a:off x="3401280" y="3791880"/>
                <a:ext cx="0" cy="406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>
                <a:off x="3401280" y="4198680"/>
                <a:ext cx="10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 flipV="1">
                <a:off x="3411720" y="4091040"/>
                <a:ext cx="0" cy="106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"/>
              <p:cNvSpPr/>
              <p:nvPr/>
            </p:nvSpPr>
            <p:spPr>
              <a:xfrm>
                <a:off x="3411720" y="4091400"/>
                <a:ext cx="10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 flipV="1">
                <a:off x="3422520" y="3974040"/>
                <a:ext cx="0" cy="1173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>
                <a:off x="3422520" y="3974040"/>
                <a:ext cx="428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 flipV="1">
                <a:off x="3465360" y="3834720"/>
                <a:ext cx="0" cy="1389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>
                <a:off x="3465360" y="383472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 flipV="1">
                <a:off x="3465360" y="3705840"/>
                <a:ext cx="0" cy="1285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>
                <a:off x="3465360" y="3706200"/>
                <a:ext cx="31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 flipV="1">
                <a:off x="3497400" y="3599640"/>
                <a:ext cx="0" cy="1065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>
                <a:off x="3497400" y="3599640"/>
                <a:ext cx="428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 flipV="1">
                <a:off x="3540240" y="3524400"/>
                <a:ext cx="0" cy="745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720" bIns="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>
                <a:off x="3540240" y="3524760"/>
                <a:ext cx="21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>
                <a:off x="3540240" y="3599640"/>
                <a:ext cx="0" cy="745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720" bIns="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>
                <a:off x="3540240" y="3674160"/>
                <a:ext cx="532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 flipV="1">
                <a:off x="3593520" y="3620880"/>
                <a:ext cx="0" cy="53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480" bIns="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>
                <a:off x="3593520" y="362088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>
                <a:off x="3593520" y="3674160"/>
                <a:ext cx="0" cy="42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>
                <a:off x="3593520" y="371700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>
                <a:off x="3497400" y="3706200"/>
                <a:ext cx="0" cy="106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>
                <a:off x="3497400" y="3813480"/>
                <a:ext cx="745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"/>
              <p:cNvSpPr/>
              <p:nvPr/>
            </p:nvSpPr>
            <p:spPr>
              <a:xfrm>
                <a:off x="3465360" y="3834720"/>
                <a:ext cx="0" cy="127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"/>
              <p:cNvSpPr/>
              <p:nvPr/>
            </p:nvSpPr>
            <p:spPr>
              <a:xfrm>
                <a:off x="3465360" y="3962880"/>
                <a:ext cx="849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 flipV="1">
                <a:off x="3550680" y="3920040"/>
                <a:ext cx="0" cy="42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" bIns="-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>
                <a:off x="3550680" y="3920400"/>
                <a:ext cx="21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>
                <a:off x="3550680" y="3962880"/>
                <a:ext cx="0" cy="53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>
                <a:off x="3550680" y="4016880"/>
                <a:ext cx="320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>
                <a:off x="3465360" y="3974040"/>
                <a:ext cx="0" cy="1389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>
                <a:off x="3465360" y="4113000"/>
                <a:ext cx="96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"/>
              <p:cNvSpPr/>
              <p:nvPr/>
            </p:nvSpPr>
            <p:spPr>
              <a:xfrm>
                <a:off x="3422520" y="4091400"/>
                <a:ext cx="0" cy="1173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>
                <a:off x="3422520" y="4209120"/>
                <a:ext cx="21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"/>
              <p:cNvSpPr/>
              <p:nvPr/>
            </p:nvSpPr>
            <p:spPr>
              <a:xfrm>
                <a:off x="3411720" y="4198680"/>
                <a:ext cx="0" cy="1065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>
                <a:off x="3411720" y="4305240"/>
                <a:ext cx="1602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>
                <a:off x="717120" y="3086280"/>
                <a:ext cx="0" cy="2438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>
                <a:off x="717120" y="5524560"/>
                <a:ext cx="5130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 flipV="1">
                <a:off x="1230480" y="4775760"/>
                <a:ext cx="0" cy="748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>
                <a:off x="1230480" y="4776120"/>
                <a:ext cx="3416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 flipV="1">
                <a:off x="1572120" y="4658400"/>
                <a:ext cx="0" cy="1173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>
                <a:off x="1572120" y="4658400"/>
                <a:ext cx="1602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"/>
              <p:cNvSpPr/>
              <p:nvPr/>
            </p:nvSpPr>
            <p:spPr>
              <a:xfrm flipV="1">
                <a:off x="1732680" y="4540680"/>
                <a:ext cx="0" cy="1173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"/>
              <p:cNvSpPr/>
              <p:nvPr/>
            </p:nvSpPr>
            <p:spPr>
              <a:xfrm>
                <a:off x="1732680" y="4540680"/>
                <a:ext cx="10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"/>
              <p:cNvSpPr/>
              <p:nvPr/>
            </p:nvSpPr>
            <p:spPr>
              <a:xfrm flipV="1">
                <a:off x="1743480" y="4455360"/>
                <a:ext cx="0" cy="849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160" bIns="38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"/>
              <p:cNvSpPr/>
              <p:nvPr/>
            </p:nvSpPr>
            <p:spPr>
              <a:xfrm>
                <a:off x="1743480" y="4455360"/>
                <a:ext cx="31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"/>
              <p:cNvSpPr/>
              <p:nvPr/>
            </p:nvSpPr>
            <p:spPr>
              <a:xfrm flipV="1">
                <a:off x="1775520" y="4401360"/>
                <a:ext cx="0" cy="53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"/>
              <p:cNvSpPr/>
              <p:nvPr/>
            </p:nvSpPr>
            <p:spPr>
              <a:xfrm>
                <a:off x="1775520" y="4401720"/>
                <a:ext cx="1285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"/>
              <p:cNvSpPr/>
              <p:nvPr/>
            </p:nvSpPr>
            <p:spPr>
              <a:xfrm>
                <a:off x="1775520" y="4455360"/>
                <a:ext cx="0" cy="42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" bIns="-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"/>
              <p:cNvSpPr/>
              <p:nvPr/>
            </p:nvSpPr>
            <p:spPr>
              <a:xfrm>
                <a:off x="1775520" y="4497840"/>
                <a:ext cx="1069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"/>
              <p:cNvSpPr/>
              <p:nvPr/>
            </p:nvSpPr>
            <p:spPr>
              <a:xfrm>
                <a:off x="1743480" y="4540680"/>
                <a:ext cx="0" cy="106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"/>
              <p:cNvSpPr/>
              <p:nvPr/>
            </p:nvSpPr>
            <p:spPr>
              <a:xfrm>
                <a:off x="1743480" y="4647960"/>
                <a:ext cx="192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"/>
              <p:cNvSpPr/>
              <p:nvPr/>
            </p:nvSpPr>
            <p:spPr>
              <a:xfrm flipV="1">
                <a:off x="1936080" y="4593600"/>
                <a:ext cx="0" cy="53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"/>
              <p:cNvSpPr/>
              <p:nvPr/>
            </p:nvSpPr>
            <p:spPr>
              <a:xfrm>
                <a:off x="1936080" y="459396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"/>
              <p:cNvSpPr/>
              <p:nvPr/>
            </p:nvSpPr>
            <p:spPr>
              <a:xfrm>
                <a:off x="1936080" y="4647960"/>
                <a:ext cx="0" cy="53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480" bIns="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"/>
              <p:cNvSpPr/>
              <p:nvPr/>
            </p:nvSpPr>
            <p:spPr>
              <a:xfrm>
                <a:off x="1936080" y="470124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"/>
              <p:cNvSpPr/>
              <p:nvPr/>
            </p:nvSpPr>
            <p:spPr>
              <a:xfrm>
                <a:off x="1732680" y="4658400"/>
                <a:ext cx="0" cy="1389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"/>
              <p:cNvSpPr/>
              <p:nvPr/>
            </p:nvSpPr>
            <p:spPr>
              <a:xfrm>
                <a:off x="1732680" y="4797360"/>
                <a:ext cx="1069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"/>
              <p:cNvSpPr/>
              <p:nvPr/>
            </p:nvSpPr>
            <p:spPr>
              <a:xfrm>
                <a:off x="1572120" y="4776120"/>
                <a:ext cx="0" cy="1173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"/>
              <p:cNvSpPr/>
              <p:nvPr/>
            </p:nvSpPr>
            <p:spPr>
              <a:xfrm>
                <a:off x="1572120" y="4893480"/>
                <a:ext cx="181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"/>
              <p:cNvSpPr/>
              <p:nvPr/>
            </p:nvSpPr>
            <p:spPr>
              <a:xfrm>
                <a:off x="1230480" y="5524560"/>
                <a:ext cx="0" cy="5133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"/>
              <p:cNvSpPr/>
              <p:nvPr/>
            </p:nvSpPr>
            <p:spPr>
              <a:xfrm>
                <a:off x="1230480" y="6037920"/>
                <a:ext cx="745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"/>
              <p:cNvSpPr/>
              <p:nvPr/>
            </p:nvSpPr>
            <p:spPr>
              <a:xfrm flipV="1">
                <a:off x="1305000" y="5760000"/>
                <a:ext cx="0" cy="277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"/>
              <p:cNvSpPr/>
              <p:nvPr/>
            </p:nvSpPr>
            <p:spPr>
              <a:xfrm>
                <a:off x="1305000" y="5760000"/>
                <a:ext cx="127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"/>
              <p:cNvSpPr/>
              <p:nvPr/>
            </p:nvSpPr>
            <p:spPr>
              <a:xfrm flipV="1">
                <a:off x="1433160" y="5609880"/>
                <a:ext cx="0" cy="149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"/>
              <p:cNvSpPr/>
              <p:nvPr/>
            </p:nvSpPr>
            <p:spPr>
              <a:xfrm>
                <a:off x="1433160" y="5610240"/>
                <a:ext cx="85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"/>
              <p:cNvSpPr/>
              <p:nvPr/>
            </p:nvSpPr>
            <p:spPr>
              <a:xfrm flipV="1">
                <a:off x="1518840" y="5460480"/>
                <a:ext cx="0" cy="149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43" name=""/>
            <p:cNvSpPr/>
            <p:nvPr/>
          </p:nvSpPr>
          <p:spPr>
            <a:xfrm>
              <a:off x="1519200" y="5461200"/>
              <a:ext cx="1069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 flipV="1">
              <a:off x="1626480" y="5353560"/>
              <a:ext cx="0" cy="106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1626480" y="5353920"/>
              <a:ext cx="745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 flipV="1">
              <a:off x="1701000" y="5246640"/>
              <a:ext cx="0" cy="106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1701000" y="5247000"/>
              <a:ext cx="2883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 flipV="1">
              <a:off x="1989720" y="5086800"/>
              <a:ext cx="0" cy="1598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1989720" y="5086800"/>
              <a:ext cx="2134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 flipV="1">
              <a:off x="2203560" y="4990320"/>
              <a:ext cx="0" cy="964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2203560" y="4990320"/>
              <a:ext cx="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2203560" y="5086800"/>
              <a:ext cx="0" cy="1065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2203560" y="5193720"/>
              <a:ext cx="2354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 flipV="1">
              <a:off x="2439360" y="5118480"/>
              <a:ext cx="0" cy="745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2439360" y="5118840"/>
              <a:ext cx="208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 flipV="1">
              <a:off x="2460240" y="5086800"/>
              <a:ext cx="0" cy="316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2460240" y="5086800"/>
              <a:ext cx="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2460240" y="5118840"/>
              <a:ext cx="0" cy="640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280" bIns="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2460240" y="5182920"/>
              <a:ext cx="16365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2439360" y="5193720"/>
              <a:ext cx="0" cy="856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2439360" y="5279400"/>
              <a:ext cx="1922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1989720" y="5247000"/>
              <a:ext cx="0" cy="1285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1989720" y="5375520"/>
              <a:ext cx="212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1701000" y="5353920"/>
              <a:ext cx="0" cy="1173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1701000" y="5471640"/>
              <a:ext cx="3099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1626480" y="5461200"/>
              <a:ext cx="0" cy="1173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1626480" y="5578920"/>
              <a:ext cx="2779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1519200" y="5610960"/>
              <a:ext cx="0" cy="1389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1519200" y="5749920"/>
              <a:ext cx="428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 flipV="1">
              <a:off x="1562040" y="5674680"/>
              <a:ext cx="0" cy="745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>
              <a:off x="1562040" y="5675040"/>
              <a:ext cx="1389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1562040" y="5749920"/>
              <a:ext cx="0" cy="640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280" bIns="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>
              <a:off x="1562040" y="5814000"/>
              <a:ext cx="856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 flipV="1">
              <a:off x="1647720" y="5770800"/>
              <a:ext cx="0" cy="428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>
              <a:off x="1647720" y="5771160"/>
              <a:ext cx="316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1647720" y="5814000"/>
              <a:ext cx="0" cy="532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480" bIns="6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1647720" y="5867640"/>
              <a:ext cx="849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1433520" y="5760360"/>
              <a:ext cx="0" cy="203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>
              <a:off x="1433520" y="5963760"/>
              <a:ext cx="2995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1305360" y="6038640"/>
              <a:ext cx="0" cy="3528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>
              <a:off x="1305360" y="6391440"/>
              <a:ext cx="3099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 flipV="1">
              <a:off x="1615320" y="6188040"/>
              <a:ext cx="0" cy="2026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"/>
            <p:cNvSpPr/>
            <p:nvPr/>
          </p:nvSpPr>
          <p:spPr>
            <a:xfrm>
              <a:off x="1615320" y="6188400"/>
              <a:ext cx="1173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 flipV="1">
              <a:off x="1733040" y="6059520"/>
              <a:ext cx="0" cy="1285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>
              <a:off x="1733040" y="6059880"/>
              <a:ext cx="3528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"/>
            <p:cNvSpPr/>
            <p:nvPr/>
          </p:nvSpPr>
          <p:spPr>
            <a:xfrm>
              <a:off x="1733040" y="6188400"/>
              <a:ext cx="0" cy="1173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"/>
            <p:cNvSpPr/>
            <p:nvPr/>
          </p:nvSpPr>
          <p:spPr>
            <a:xfrm>
              <a:off x="1733040" y="6306120"/>
              <a:ext cx="1818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 flipV="1">
              <a:off x="1914840" y="6209640"/>
              <a:ext cx="0" cy="961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1914840" y="6210000"/>
              <a:ext cx="1069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"/>
            <p:cNvSpPr/>
            <p:nvPr/>
          </p:nvSpPr>
          <p:spPr>
            <a:xfrm flipV="1">
              <a:off x="2022120" y="6155640"/>
              <a:ext cx="0" cy="536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2022120" y="6156000"/>
              <a:ext cx="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2022120" y="6210000"/>
              <a:ext cx="0" cy="428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>
              <a:off x="2022120" y="6252840"/>
              <a:ext cx="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"/>
            <p:cNvSpPr/>
            <p:nvPr/>
          </p:nvSpPr>
          <p:spPr>
            <a:xfrm>
              <a:off x="1914840" y="6306120"/>
              <a:ext cx="0" cy="961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"/>
            <p:cNvSpPr/>
            <p:nvPr/>
          </p:nvSpPr>
          <p:spPr>
            <a:xfrm>
              <a:off x="1914840" y="6402240"/>
              <a:ext cx="532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"/>
            <p:cNvSpPr/>
            <p:nvPr/>
          </p:nvSpPr>
          <p:spPr>
            <a:xfrm flipV="1">
              <a:off x="1968120" y="6359040"/>
              <a:ext cx="0" cy="428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"/>
            <p:cNvSpPr/>
            <p:nvPr/>
          </p:nvSpPr>
          <p:spPr>
            <a:xfrm>
              <a:off x="1968120" y="6359400"/>
              <a:ext cx="964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"/>
            <p:cNvSpPr/>
            <p:nvPr/>
          </p:nvSpPr>
          <p:spPr>
            <a:xfrm>
              <a:off x="1968120" y="6402240"/>
              <a:ext cx="0" cy="532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480" bIns="6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>
              <a:off x="1968120" y="6455880"/>
              <a:ext cx="1389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"/>
            <p:cNvSpPr/>
            <p:nvPr/>
          </p:nvSpPr>
          <p:spPr>
            <a:xfrm>
              <a:off x="1615320" y="6391440"/>
              <a:ext cx="0" cy="2142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"/>
            <p:cNvSpPr/>
            <p:nvPr/>
          </p:nvSpPr>
          <p:spPr>
            <a:xfrm>
              <a:off x="1615320" y="6605640"/>
              <a:ext cx="2030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"/>
            <p:cNvSpPr/>
            <p:nvPr/>
          </p:nvSpPr>
          <p:spPr>
            <a:xfrm flipV="1">
              <a:off x="1818720" y="6551640"/>
              <a:ext cx="0" cy="536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"/>
            <p:cNvSpPr/>
            <p:nvPr/>
          </p:nvSpPr>
          <p:spPr>
            <a:xfrm>
              <a:off x="1818720" y="6552000"/>
              <a:ext cx="2030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"/>
            <p:cNvSpPr/>
            <p:nvPr/>
          </p:nvSpPr>
          <p:spPr>
            <a:xfrm>
              <a:off x="1818720" y="6605640"/>
              <a:ext cx="0" cy="421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"/>
            <p:cNvSpPr/>
            <p:nvPr/>
          </p:nvSpPr>
          <p:spPr>
            <a:xfrm>
              <a:off x="1818720" y="6648120"/>
              <a:ext cx="1069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1877040" y="18792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1g688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"/>
            <p:cNvSpPr/>
            <p:nvPr/>
          </p:nvSpPr>
          <p:spPr>
            <a:xfrm>
              <a:off x="2005200" y="28404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1g672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"/>
            <p:cNvSpPr/>
            <p:nvPr/>
          </p:nvSpPr>
          <p:spPr>
            <a:xfrm>
              <a:off x="1738800" y="38016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9g2448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"/>
            <p:cNvSpPr/>
            <p:nvPr/>
          </p:nvSpPr>
          <p:spPr>
            <a:xfrm>
              <a:off x="1687680" y="47664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4g2998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"/>
            <p:cNvSpPr/>
            <p:nvPr/>
          </p:nvSpPr>
          <p:spPr>
            <a:xfrm>
              <a:off x="1749960" y="57276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8g3353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"/>
            <p:cNvSpPr/>
            <p:nvPr/>
          </p:nvSpPr>
          <p:spPr>
            <a:xfrm>
              <a:off x="1763280" y="66888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3g3659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"/>
            <p:cNvSpPr/>
            <p:nvPr/>
          </p:nvSpPr>
          <p:spPr>
            <a:xfrm>
              <a:off x="1888920" y="76500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3g4988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"/>
            <p:cNvSpPr/>
            <p:nvPr/>
          </p:nvSpPr>
          <p:spPr>
            <a:xfrm>
              <a:off x="1838160" y="86184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1g110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"/>
            <p:cNvSpPr/>
            <p:nvPr/>
          </p:nvSpPr>
          <p:spPr>
            <a:xfrm>
              <a:off x="1737000" y="96840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3g1855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"/>
            <p:cNvSpPr/>
            <p:nvPr/>
          </p:nvSpPr>
          <p:spPr>
            <a:xfrm>
              <a:off x="2913480" y="106488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3g4515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"/>
            <p:cNvSpPr/>
            <p:nvPr/>
          </p:nvSpPr>
          <p:spPr>
            <a:xfrm>
              <a:off x="3620160" y="116100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5g4103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"/>
            <p:cNvSpPr/>
            <p:nvPr/>
          </p:nvSpPr>
          <p:spPr>
            <a:xfrm>
              <a:off x="3781800" y="125712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4g1183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"/>
            <p:cNvSpPr/>
            <p:nvPr/>
          </p:nvSpPr>
          <p:spPr>
            <a:xfrm>
              <a:off x="3795480" y="135360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5g0288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"/>
            <p:cNvSpPr/>
            <p:nvPr/>
          </p:nvSpPr>
          <p:spPr>
            <a:xfrm>
              <a:off x="3748680" y="145008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2g370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"/>
            <p:cNvSpPr/>
            <p:nvPr/>
          </p:nvSpPr>
          <p:spPr>
            <a:xfrm>
              <a:off x="3592440" y="1546200"/>
              <a:ext cx="639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9900"/>
                  </a:solidFill>
                  <a:latin typeface="Times New Roman"/>
                </a:rPr>
                <a:t>At5g08330_CHE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"/>
            <p:cNvSpPr/>
            <p:nvPr/>
          </p:nvSpPr>
          <p:spPr>
            <a:xfrm>
              <a:off x="3746880" y="1642320"/>
              <a:ext cx="418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Bd3g6035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"/>
            <p:cNvSpPr/>
            <p:nvPr/>
          </p:nvSpPr>
          <p:spPr>
            <a:xfrm>
              <a:off x="3597840" y="174960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5g2328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"/>
            <p:cNvSpPr/>
            <p:nvPr/>
          </p:nvSpPr>
          <p:spPr>
            <a:xfrm>
              <a:off x="3813840" y="184572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4g4444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"/>
            <p:cNvSpPr/>
            <p:nvPr/>
          </p:nvSpPr>
          <p:spPr>
            <a:xfrm>
              <a:off x="3813840" y="194184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2g4238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"/>
            <p:cNvSpPr/>
            <p:nvPr/>
          </p:nvSpPr>
          <p:spPr>
            <a:xfrm>
              <a:off x="3859560" y="203832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5g1627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"/>
            <p:cNvSpPr/>
            <p:nvPr/>
          </p:nvSpPr>
          <p:spPr>
            <a:xfrm>
              <a:off x="3773880" y="213444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3g496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"/>
            <p:cNvSpPr/>
            <p:nvPr/>
          </p:nvSpPr>
          <p:spPr>
            <a:xfrm>
              <a:off x="3634920" y="223056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4g2455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"/>
            <p:cNvSpPr/>
            <p:nvPr/>
          </p:nvSpPr>
          <p:spPr>
            <a:xfrm>
              <a:off x="3664440" y="232668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1g6998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"/>
            <p:cNvSpPr/>
            <p:nvPr/>
          </p:nvSpPr>
          <p:spPr>
            <a:xfrm>
              <a:off x="3656520" y="242316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2g5924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"/>
            <p:cNvSpPr/>
            <p:nvPr/>
          </p:nvSpPr>
          <p:spPr>
            <a:xfrm>
              <a:off x="3651480" y="251964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3g270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"/>
            <p:cNvSpPr/>
            <p:nvPr/>
          </p:nvSpPr>
          <p:spPr>
            <a:xfrm>
              <a:off x="3768840" y="262656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2g4568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"/>
            <p:cNvSpPr/>
            <p:nvPr/>
          </p:nvSpPr>
          <p:spPr>
            <a:xfrm>
              <a:off x="3748680" y="272268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5g519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"/>
            <p:cNvSpPr/>
            <p:nvPr/>
          </p:nvSpPr>
          <p:spPr>
            <a:xfrm>
              <a:off x="3803400" y="281880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8g431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"/>
            <p:cNvSpPr/>
            <p:nvPr/>
          </p:nvSpPr>
          <p:spPr>
            <a:xfrm>
              <a:off x="3795480" y="291564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4g3567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"/>
            <p:cNvSpPr/>
            <p:nvPr/>
          </p:nvSpPr>
          <p:spPr>
            <a:xfrm>
              <a:off x="4113360" y="301176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9g3495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"/>
            <p:cNvSpPr/>
            <p:nvPr/>
          </p:nvSpPr>
          <p:spPr>
            <a:xfrm>
              <a:off x="4008600" y="310788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4g3552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"/>
            <p:cNvSpPr/>
            <p:nvPr/>
          </p:nvSpPr>
          <p:spPr>
            <a:xfrm>
              <a:off x="3437640" y="320400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1g720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"/>
            <p:cNvSpPr/>
            <p:nvPr/>
          </p:nvSpPr>
          <p:spPr>
            <a:xfrm>
              <a:off x="3482280" y="330048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12g0748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"/>
            <p:cNvSpPr/>
            <p:nvPr/>
          </p:nvSpPr>
          <p:spPr>
            <a:xfrm>
              <a:off x="3474360" y="340740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4g4143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"/>
            <p:cNvSpPr/>
            <p:nvPr/>
          </p:nvSpPr>
          <p:spPr>
            <a:xfrm>
              <a:off x="3600000" y="350388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11g074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"/>
            <p:cNvSpPr/>
            <p:nvPr/>
          </p:nvSpPr>
          <p:spPr>
            <a:xfrm>
              <a:off x="3632040" y="360000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2g5128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"/>
            <p:cNvSpPr/>
            <p:nvPr/>
          </p:nvSpPr>
          <p:spPr>
            <a:xfrm>
              <a:off x="3624480" y="369612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3g5932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"/>
            <p:cNvSpPr/>
            <p:nvPr/>
          </p:nvSpPr>
          <p:spPr>
            <a:xfrm>
              <a:off x="3597840" y="379224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1g6969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"/>
            <p:cNvSpPr/>
            <p:nvPr/>
          </p:nvSpPr>
          <p:spPr>
            <a:xfrm>
              <a:off x="3621600" y="388872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6g1223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"/>
            <p:cNvSpPr/>
            <p:nvPr/>
          </p:nvSpPr>
          <p:spPr>
            <a:xfrm>
              <a:off x="3624480" y="398484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1g4522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"/>
            <p:cNvSpPr/>
            <p:nvPr/>
          </p:nvSpPr>
          <p:spPr>
            <a:xfrm>
              <a:off x="3597840" y="408096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3g4762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"/>
            <p:cNvSpPr/>
            <p:nvPr/>
          </p:nvSpPr>
          <p:spPr>
            <a:xfrm>
              <a:off x="3480480" y="417780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1g58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"/>
            <p:cNvSpPr/>
            <p:nvPr/>
          </p:nvSpPr>
          <p:spPr>
            <a:xfrm>
              <a:off x="3608640" y="428436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1g355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"/>
            <p:cNvSpPr/>
            <p:nvPr/>
          </p:nvSpPr>
          <p:spPr>
            <a:xfrm>
              <a:off x="1940400" y="438048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3g1503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"/>
            <p:cNvSpPr/>
            <p:nvPr/>
          </p:nvSpPr>
          <p:spPr>
            <a:xfrm>
              <a:off x="1909080" y="447696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1g5323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"/>
            <p:cNvSpPr/>
            <p:nvPr/>
          </p:nvSpPr>
          <p:spPr>
            <a:xfrm>
              <a:off x="1974240" y="457344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1g1155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"/>
            <p:cNvSpPr/>
            <p:nvPr/>
          </p:nvSpPr>
          <p:spPr>
            <a:xfrm>
              <a:off x="1966320" y="466956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2g0689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"/>
            <p:cNvSpPr/>
            <p:nvPr/>
          </p:nvSpPr>
          <p:spPr>
            <a:xfrm>
              <a:off x="1877040" y="476568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2g3107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"/>
            <p:cNvSpPr/>
            <p:nvPr/>
          </p:nvSpPr>
          <p:spPr>
            <a:xfrm>
              <a:off x="1795320" y="486216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2g5019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"/>
            <p:cNvSpPr/>
            <p:nvPr/>
          </p:nvSpPr>
          <p:spPr>
            <a:xfrm>
              <a:off x="2252160" y="495828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12g4219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"/>
            <p:cNvSpPr/>
            <p:nvPr/>
          </p:nvSpPr>
          <p:spPr>
            <a:xfrm>
              <a:off x="2498400" y="506556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7g045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"/>
            <p:cNvSpPr/>
            <p:nvPr/>
          </p:nvSpPr>
          <p:spPr>
            <a:xfrm>
              <a:off x="4145400" y="516168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2g513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"/>
            <p:cNvSpPr/>
            <p:nvPr/>
          </p:nvSpPr>
          <p:spPr>
            <a:xfrm>
              <a:off x="2680560" y="525780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12g0209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"/>
            <p:cNvSpPr/>
            <p:nvPr/>
          </p:nvSpPr>
          <p:spPr>
            <a:xfrm>
              <a:off x="2052000" y="535392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4g0155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"/>
            <p:cNvSpPr/>
            <p:nvPr/>
          </p:nvSpPr>
          <p:spPr>
            <a:xfrm>
              <a:off x="2048040" y="545040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1g302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"/>
            <p:cNvSpPr/>
            <p:nvPr/>
          </p:nvSpPr>
          <p:spPr>
            <a:xfrm>
              <a:off x="1945440" y="554652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1g064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"/>
            <p:cNvSpPr/>
            <p:nvPr/>
          </p:nvSpPr>
          <p:spPr>
            <a:xfrm>
              <a:off x="1749960" y="564264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3g5719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"/>
            <p:cNvSpPr/>
            <p:nvPr/>
          </p:nvSpPr>
          <p:spPr>
            <a:xfrm>
              <a:off x="1717560" y="573948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7g0572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"/>
            <p:cNvSpPr/>
            <p:nvPr/>
          </p:nvSpPr>
          <p:spPr>
            <a:xfrm>
              <a:off x="1763280" y="583560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1g5845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"/>
            <p:cNvSpPr/>
            <p:nvPr/>
          </p:nvSpPr>
          <p:spPr>
            <a:xfrm>
              <a:off x="1769040" y="594216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4g1839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"/>
            <p:cNvSpPr/>
            <p:nvPr/>
          </p:nvSpPr>
          <p:spPr>
            <a:xfrm>
              <a:off x="2112480" y="603864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3g0215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"/>
            <p:cNvSpPr/>
            <p:nvPr/>
          </p:nvSpPr>
          <p:spPr>
            <a:xfrm>
              <a:off x="2059920" y="613476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1g5575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"/>
            <p:cNvSpPr/>
            <p:nvPr/>
          </p:nvSpPr>
          <p:spPr>
            <a:xfrm>
              <a:off x="2052000" y="623124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2g5069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"/>
            <p:cNvSpPr/>
            <p:nvPr/>
          </p:nvSpPr>
          <p:spPr>
            <a:xfrm>
              <a:off x="2102760" y="6327720"/>
              <a:ext cx="45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s05g437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"/>
            <p:cNvSpPr/>
            <p:nvPr/>
          </p:nvSpPr>
          <p:spPr>
            <a:xfrm>
              <a:off x="2148120" y="642384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d2g200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"/>
            <p:cNvSpPr/>
            <p:nvPr/>
          </p:nvSpPr>
          <p:spPr>
            <a:xfrm>
              <a:off x="2057760" y="651996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5g6097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"/>
            <p:cNvSpPr/>
            <p:nvPr/>
          </p:nvSpPr>
          <p:spPr>
            <a:xfrm>
              <a:off x="1951920" y="6614640"/>
              <a:ext cx="398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t5g0807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73" name=""/>
          <p:cNvSpPr/>
          <p:nvPr/>
        </p:nvSpPr>
        <p:spPr>
          <a:xfrm>
            <a:off x="1017720" y="53028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"/>
          <p:cNvSpPr/>
          <p:nvPr/>
        </p:nvSpPr>
        <p:spPr>
          <a:xfrm>
            <a:off x="2146680" y="1150920"/>
            <a:ext cx="30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"/>
          <p:cNvSpPr/>
          <p:nvPr/>
        </p:nvSpPr>
        <p:spPr>
          <a:xfrm>
            <a:off x="3534120" y="193824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"/>
          <p:cNvSpPr/>
          <p:nvPr/>
        </p:nvSpPr>
        <p:spPr>
          <a:xfrm>
            <a:off x="3416400" y="225576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"/>
          <p:cNvSpPr/>
          <p:nvPr/>
        </p:nvSpPr>
        <p:spPr>
          <a:xfrm>
            <a:off x="1822680" y="606744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"/>
          <p:cNvSpPr/>
          <p:nvPr/>
        </p:nvSpPr>
        <p:spPr>
          <a:xfrm>
            <a:off x="1538640" y="69840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"/>
          <p:cNvSpPr/>
          <p:nvPr/>
        </p:nvSpPr>
        <p:spPr>
          <a:xfrm>
            <a:off x="3062520" y="126684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"/>
          <p:cNvSpPr/>
          <p:nvPr/>
        </p:nvSpPr>
        <p:spPr>
          <a:xfrm>
            <a:off x="2875320" y="140004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"/>
          <p:cNvSpPr/>
          <p:nvPr/>
        </p:nvSpPr>
        <p:spPr>
          <a:xfrm>
            <a:off x="1737000" y="450864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"/>
          <p:cNvSpPr/>
          <p:nvPr/>
        </p:nvSpPr>
        <p:spPr>
          <a:xfrm>
            <a:off x="1797120" y="510372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"/>
          <p:cNvSpPr/>
          <p:nvPr/>
        </p:nvSpPr>
        <p:spPr>
          <a:xfrm>
            <a:off x="4859280" y="476280"/>
            <a:ext cx="2592360" cy="129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At = Arabidops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Os = Ric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Bd = Brachypodiu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Bootstrap support of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≥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90% show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(1000 dataset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86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23T09:04:27Z</dcterms:created>
  <dc:creator>baileyp</dc:creator>
  <dc:description/>
  <dc:language>en-US</dc:language>
  <cp:lastModifiedBy>Janet Higgins</cp:lastModifiedBy>
  <dcterms:modified xsi:type="dcterms:W3CDTF">2010-01-06T11:56:30Z</dcterms:modified>
  <cp:revision>85</cp:revision>
  <dc:subject/>
  <dc:title>Slide 1</dc:title>
</cp:coreProperties>
</file>